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72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83067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0276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6051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2872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40168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898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96533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6483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88661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3219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3594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B10428-A40B-43DD-87A6-6FA88C833278}" type="datetimeFigureOut">
              <a:rPr lang="en-IN" smtClean="0"/>
              <a:t>16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72A04B-7779-4760-B4B1-E13BDD1A74C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08179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971800" y="6334780"/>
            <a:ext cx="3505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A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Blank;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mpicillin;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C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Extract</a:t>
            </a:r>
          </a:p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D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50 µg/ ml;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E: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100 µg/ ml;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: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200 µg/ ml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75"/>
          <p:cNvGrpSpPr/>
          <p:nvPr/>
        </p:nvGrpSpPr>
        <p:grpSpPr>
          <a:xfrm>
            <a:off x="304800" y="228600"/>
            <a:ext cx="8458200" cy="6140887"/>
            <a:chOff x="304800" y="228600"/>
            <a:chExt cx="8458200" cy="6140887"/>
          </a:xfrm>
        </p:grpSpPr>
        <p:grpSp>
          <p:nvGrpSpPr>
            <p:cNvPr id="3" name="Group 12"/>
            <p:cNvGrpSpPr/>
            <p:nvPr/>
          </p:nvGrpSpPr>
          <p:grpSpPr>
            <a:xfrm>
              <a:off x="4876800" y="3352800"/>
              <a:ext cx="2743200" cy="3016687"/>
              <a:chOff x="5756910" y="3234690"/>
              <a:chExt cx="2743200" cy="3016687"/>
            </a:xfrm>
          </p:grpSpPr>
          <p:pic>
            <p:nvPicPr>
              <p:cNvPr id="4" name="Picture 3" descr="20200826_113743.jpg"/>
              <p:cNvPicPr>
                <a:picLocks noChangeAspect="1"/>
              </p:cNvPicPr>
              <p:nvPr/>
            </p:nvPicPr>
            <p:blipFill>
              <a:blip r:embed="rId2" cstate="print"/>
              <a:srcRect l="17500" t="3333" r="17500" b="7778"/>
              <a:stretch>
                <a:fillRect/>
              </a:stretch>
            </p:blipFill>
            <p:spPr>
              <a:xfrm rot="5400000">
                <a:off x="5791200" y="3200400"/>
                <a:ext cx="2674620" cy="2743200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6553200" y="5943600"/>
                <a:ext cx="1524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B. </a:t>
                </a:r>
                <a:r>
                  <a:rPr lang="en-US" sz="1400" i="1" dirty="0" err="1" smtClean="0">
                    <a:latin typeface="Times New Roman" pitchFamily="18" charset="0"/>
                    <a:cs typeface="Times New Roman" pitchFamily="18" charset="0"/>
                  </a:rPr>
                  <a:t>subitilis</a:t>
                </a:r>
                <a:endParaRPr 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6324600" y="35052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6400800" y="5334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791200" y="43434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7696200" y="52578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077200" y="43434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7543800" y="3429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3" name="Group 21"/>
            <p:cNvGrpSpPr/>
            <p:nvPr/>
          </p:nvGrpSpPr>
          <p:grpSpPr>
            <a:xfrm>
              <a:off x="3124200" y="228600"/>
              <a:ext cx="2743200" cy="2971800"/>
              <a:chOff x="2362200" y="381000"/>
              <a:chExt cx="2743200" cy="3043093"/>
            </a:xfrm>
          </p:grpSpPr>
          <p:pic>
            <p:nvPicPr>
              <p:cNvPr id="14" name="Picture 13" descr="20200826_111931.jpg"/>
              <p:cNvPicPr>
                <a:picLocks noChangeAspect="1"/>
              </p:cNvPicPr>
              <p:nvPr/>
            </p:nvPicPr>
            <p:blipFill>
              <a:blip r:embed="rId3" cstate="print"/>
              <a:srcRect l="16667" t="13333" r="22500" b="5556"/>
              <a:stretch>
                <a:fillRect/>
              </a:stretch>
            </p:blipFill>
            <p:spPr>
              <a:xfrm rot="16200000">
                <a:off x="2362200" y="381000"/>
                <a:ext cx="2743200" cy="274320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3326027" y="3116316"/>
                <a:ext cx="762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E. coli</a:t>
                </a:r>
                <a:endParaRPr 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429000" y="4572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648200" y="9906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648200" y="1944038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886200" y="2667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667000" y="2334797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514600" y="12954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2" name="Group 52"/>
            <p:cNvGrpSpPr/>
            <p:nvPr/>
          </p:nvGrpSpPr>
          <p:grpSpPr>
            <a:xfrm>
              <a:off x="1600200" y="3352800"/>
              <a:ext cx="2724150" cy="2974777"/>
              <a:chOff x="6096000" y="228600"/>
              <a:chExt cx="2724150" cy="2974777"/>
            </a:xfrm>
          </p:grpSpPr>
          <p:pic>
            <p:nvPicPr>
              <p:cNvPr id="44" name="Picture 43" descr="737.jpg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096000" y="228600"/>
                <a:ext cx="2724150" cy="2676525"/>
              </a:xfrm>
              <a:prstGeom prst="rect">
                <a:avLst/>
              </a:prstGeom>
            </p:spPr>
          </p:pic>
          <p:sp>
            <p:nvSpPr>
              <p:cNvPr id="45" name="TextBox 44"/>
              <p:cNvSpPr txBox="1"/>
              <p:nvPr/>
            </p:nvSpPr>
            <p:spPr>
              <a:xfrm>
                <a:off x="7239000" y="381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8305800" y="8382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8229600" y="1905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7391400" y="25146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6400800" y="20574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6248400" y="9906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7010400" y="2895600"/>
                <a:ext cx="1143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S. aureus</a:t>
                </a:r>
                <a:endParaRPr 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3" name="Group 47"/>
            <p:cNvGrpSpPr/>
            <p:nvPr/>
          </p:nvGrpSpPr>
          <p:grpSpPr>
            <a:xfrm>
              <a:off x="304800" y="228600"/>
              <a:ext cx="2733675" cy="2974777"/>
              <a:chOff x="304800" y="228600"/>
              <a:chExt cx="2733675" cy="2974777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990600" y="2895600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. aeruginosa</a:t>
                </a:r>
                <a:endParaRPr 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56" name="Picture 55" descr="P aeruginosa.jpg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04800" y="228600"/>
                <a:ext cx="2733675" cy="2733675"/>
              </a:xfrm>
              <a:prstGeom prst="rect">
                <a:avLst/>
              </a:prstGeom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609600" y="762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1676400" y="3048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2514600" y="9906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2438400" y="20574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1600200" y="25146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33400" y="1905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24" name="Group 74"/>
            <p:cNvGrpSpPr/>
            <p:nvPr/>
          </p:nvGrpSpPr>
          <p:grpSpPr>
            <a:xfrm>
              <a:off x="6019800" y="228600"/>
              <a:ext cx="2743200" cy="2974777"/>
              <a:chOff x="6019800" y="228600"/>
              <a:chExt cx="2743200" cy="2974777"/>
            </a:xfrm>
          </p:grpSpPr>
          <p:sp>
            <p:nvSpPr>
              <p:cNvPr id="55" name="TextBox 54"/>
              <p:cNvSpPr txBox="1"/>
              <p:nvPr/>
            </p:nvSpPr>
            <p:spPr>
              <a:xfrm>
                <a:off x="6858000" y="2895600"/>
                <a:ext cx="1371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. vulgaris</a:t>
                </a:r>
                <a:endParaRPr 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67" name="Picture 66" descr="p vulgaris.jpg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019800" y="228600"/>
                <a:ext cx="2743200" cy="2688336"/>
              </a:xfrm>
              <a:prstGeom prst="rect">
                <a:avLst/>
              </a:prstGeom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7391400" y="3048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8305800" y="9144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8229600" y="1905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7315200" y="25146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6248400" y="1905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6400800" y="762000"/>
                <a:ext cx="2286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en-US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76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RENDRA</dc:creator>
  <cp:lastModifiedBy>SURENDRA</cp:lastModifiedBy>
  <cp:revision>1</cp:revision>
  <dcterms:created xsi:type="dcterms:W3CDTF">2021-09-16T14:05:16Z</dcterms:created>
  <dcterms:modified xsi:type="dcterms:W3CDTF">2021-09-16T14:14:48Z</dcterms:modified>
</cp:coreProperties>
</file>